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907588" cy="68580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35600" cy="9867600"/>
          </a:xfrm>
          <a:prstGeom prst="rect">
            <a:avLst/>
          </a:prstGeom>
          <a:solidFill>
            <a:srgbClr val="ffffff"/>
          </a:solidFill>
          <a:ln w="936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0" y="0"/>
            <a:ext cx="6735600" cy="9867960"/>
          </a:xfrm>
          <a:custGeom>
            <a:avLst/>
            <a:gdLst>
              <a:gd name="textAreaLeft" fmla="*/ 360 w 6735600"/>
              <a:gd name="textAreaRight" fmla="*/ 6735240 w 6735600"/>
              <a:gd name="textAreaTop" fmla="*/ 360 h 9867960"/>
              <a:gd name="textAreaBottom" fmla="*/ 9867600 h 9867960"/>
            </a:gdLst>
            <a:ahLst/>
            <a:rect l="textAreaLeft" t="textAreaTop" r="textAreaRight" b="textAreaBottom"/>
            <a:pathLst>
              <a:path w="21600" h="31644">
                <a:moveTo>
                  <a:pt x="5" y="0"/>
                </a:moveTo>
                <a:arcTo wR="5" hR="5" stAng="16200000" swAng="-5400000"/>
                <a:lnTo>
                  <a:pt x="0" y="31639"/>
                </a:lnTo>
                <a:arcTo wR="5" hR="5" stAng="10800000" swAng="-5400000"/>
                <a:lnTo>
                  <a:pt x="21595" y="31644"/>
                </a:lnTo>
                <a:arcTo wR="5" hR="5" stAng="5400000" swAng="-5400000"/>
                <a:lnTo>
                  <a:pt x="21600" y="5"/>
                </a:lnTo>
                <a:arcTo wR="5" hR="5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0" y="0"/>
            <a:ext cx="2919240" cy="49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814920" y="0"/>
            <a:ext cx="2919240" cy="49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1"/>
          <p:cNvSpPr>
            <a:spLocks noGrp="1"/>
          </p:cNvSpPr>
          <p:nvPr>
            <p:ph type="sldImg"/>
          </p:nvPr>
        </p:nvSpPr>
        <p:spPr>
          <a:xfrm>
            <a:off x="695160" y="739440"/>
            <a:ext cx="5343840" cy="369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2"/>
          <p:cNvSpPr>
            <a:spLocks noGrp="1"/>
          </p:cNvSpPr>
          <p:nvPr>
            <p:ph type="body"/>
          </p:nvPr>
        </p:nvSpPr>
        <p:spPr>
          <a:xfrm>
            <a:off x="673200" y="4686120"/>
            <a:ext cx="5387760" cy="4438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0" y="9371160"/>
            <a:ext cx="2919240" cy="49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PlaceHolder 3"/>
          <p:cNvSpPr>
            <a:spLocks noGrp="1"/>
          </p:cNvSpPr>
          <p:nvPr>
            <p:ph type="sldNum" idx="2"/>
          </p:nvPr>
        </p:nvSpPr>
        <p:spPr>
          <a:xfrm>
            <a:off x="3814560" y="9370800"/>
            <a:ext cx="2917800" cy="49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4EE0012D-5E38-43BA-A4A0-041BAE1D5713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PlaceHolder 1"/>
          <p:cNvSpPr>
            <a:spLocks noGrp="1"/>
          </p:cNvSpPr>
          <p:nvPr>
            <p:ph type="sldImg"/>
          </p:nvPr>
        </p:nvSpPr>
        <p:spPr>
          <a:xfrm>
            <a:off x="695160" y="739800"/>
            <a:ext cx="5345280" cy="3700440"/>
          </a:xfrm>
          <a:prstGeom prst="rect">
            <a:avLst/>
          </a:prstGeom>
          <a:ln w="0">
            <a:noFill/>
          </a:ln>
        </p:spPr>
      </p:sp>
      <p:sp>
        <p:nvSpPr>
          <p:cNvPr id="114" name="PlaceHolder 2"/>
          <p:cNvSpPr>
            <a:spLocks noGrp="1"/>
          </p:cNvSpPr>
          <p:nvPr>
            <p:ph type="body"/>
          </p:nvPr>
        </p:nvSpPr>
        <p:spPr>
          <a:xfrm>
            <a:off x="672840" y="4686120"/>
            <a:ext cx="5389560" cy="4439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"/>
          <p:cNvSpPr/>
          <p:nvPr/>
        </p:nvSpPr>
        <p:spPr>
          <a:xfrm>
            <a:off x="3814920" y="9371160"/>
            <a:ext cx="2919240" cy="49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4E14AB60-CD4C-4F06-BC1D-C5A0879EA735}" type="slidenum"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0E0F729-54E1-4932-A7D8-BE89B7118164}" type="slidenum">
              <a:t>&lt;#&gt;</a:t>
            </a:fld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891360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360" y="3963600"/>
            <a:ext cx="891360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D4C2DA7C-2320-4A6C-AF9D-4F24068E77E3}" type="slidenum">
              <a:t>&lt;#&gt;</a:t>
            </a:fld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2680" y="16002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360" y="39636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2680" y="39636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CA2D89D5-F7DC-482F-9188-952F239B5018}" type="slidenum">
              <a:t>&lt;#&gt;</a:t>
            </a:fld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28699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280" y="1600200"/>
            <a:ext cx="28699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2840" y="1600200"/>
            <a:ext cx="28699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360" y="3963600"/>
            <a:ext cx="28699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280" y="3963600"/>
            <a:ext cx="28699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2840" y="3963600"/>
            <a:ext cx="28699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A52EDE7A-C19C-4B24-9EA4-B88612B9DD11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360" y="1600200"/>
            <a:ext cx="8913600" cy="4524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2EEC8E5-E2A3-48CA-A435-50A54D1DD73E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891360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23697FAA-EF7D-43EA-A88D-38507323761C}" type="slidenum">
              <a:t>&lt;#&gt;</a:t>
            </a:fld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434952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2680" y="1600200"/>
            <a:ext cx="434952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AA8D7130-F79C-4D0D-8094-1E008B96F8C2}" type="slidenum">
              <a:t>&lt;#&gt;</a:t>
            </a:fld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E568041F-EB8E-477B-BF5D-2ABF5B107AD8}" type="slidenum">
              <a:t>&lt;#&gt;</a:t>
            </a:fld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360" y="274680"/>
            <a:ext cx="8913600" cy="529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FD150479-1398-4761-9972-2B9117AD3D96}" type="slidenum">
              <a:t>&lt;#&gt;</a:t>
            </a:fld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2680" y="1600200"/>
            <a:ext cx="434952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360" y="39636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FF27A2F5-C33D-4DC6-B0EF-D83A69436B53}" type="slidenum">
              <a:t>&lt;#&gt;</a:t>
            </a:fld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434952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2680" y="16002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2680" y="39636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B01601BC-55CD-4104-8134-C376B14B206E}" type="slidenum">
              <a:t>&lt;#&gt;</a:t>
            </a:fld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360" y="16002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2680" y="1600200"/>
            <a:ext cx="434952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360" y="3963600"/>
            <a:ext cx="8913600" cy="215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1"/>
          </p:nvPr>
        </p:nvSpPr>
        <p:spPr/>
        <p:txBody>
          <a:bodyPr/>
          <a:p>
            <a:fld id="{970586FF-EBFC-4A04-9E39-7B9542299B63}" type="slidenum">
              <a:t>&lt;#&gt;</a:t>
            </a:fld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360" y="274680"/>
            <a:ext cx="8913600" cy="1141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360" y="1600200"/>
            <a:ext cx="8913600" cy="452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"/>
          <p:cNvSpPr/>
          <p:nvPr/>
        </p:nvSpPr>
        <p:spPr>
          <a:xfrm>
            <a:off x="495360" y="6245280"/>
            <a:ext cx="231120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"/>
          <p:cNvSpPr/>
          <p:nvPr/>
        </p:nvSpPr>
        <p:spPr>
          <a:xfrm>
            <a:off x="3384720" y="6245280"/>
            <a:ext cx="3136680" cy="476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1"/>
          </p:nvPr>
        </p:nvSpPr>
        <p:spPr>
          <a:xfrm>
            <a:off x="7099200" y="6245280"/>
            <a:ext cx="2309760" cy="474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fld id="{B8679489-A73C-4D72-8CB4-60ACB1C7B539}" type="slidenum">
              <a:rPr b="0" lang="en-US" sz="1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9" name="" descr=""/>
          <p:cNvPicPr/>
          <p:nvPr/>
        </p:nvPicPr>
        <p:blipFill>
          <a:blip r:embed="rId1"/>
          <a:stretch/>
        </p:blipFill>
        <p:spPr>
          <a:xfrm>
            <a:off x="849240" y="1317600"/>
            <a:ext cx="6405480" cy="4849920"/>
          </a:xfrm>
          <a:prstGeom prst="rect">
            <a:avLst/>
          </a:prstGeom>
          <a:ln w="0">
            <a:noFill/>
          </a:ln>
        </p:spPr>
      </p:pic>
      <p:sp>
        <p:nvSpPr>
          <p:cNvPr id="50" name=""/>
          <p:cNvSpPr/>
          <p:nvPr/>
        </p:nvSpPr>
        <p:spPr>
          <a:xfrm>
            <a:off x="3030480" y="6330960"/>
            <a:ext cx="2425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Head_to_tail (1620 MPs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641600" y="1895400"/>
            <a:ext cx="718920" cy="719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4881600" y="4846680"/>
            <a:ext cx="719280" cy="7189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4919760" y="1893960"/>
            <a:ext cx="718920" cy="71892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592280" y="4902120"/>
            <a:ext cx="719280" cy="71928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2217600" y="2541600"/>
            <a:ext cx="1727280" cy="3816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flipV="1">
            <a:off x="3944880" y="5538600"/>
            <a:ext cx="1154160" cy="820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03040" y="6330960"/>
            <a:ext cx="2390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Head_to_head (16 MPs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4809960" y="981000"/>
            <a:ext cx="2043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ail_to_tail (39 MPs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flipH="1">
            <a:off x="1711440" y="5621400"/>
            <a:ext cx="171360" cy="736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flipV="1">
            <a:off x="5495760" y="1387440"/>
            <a:ext cx="287640" cy="579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 flipV="1">
            <a:off x="1928880" y="2036520"/>
            <a:ext cx="3529080" cy="331452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5762520" y="6330960"/>
            <a:ext cx="3935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Group NG: Abnormal junctions (554 MPs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6165720" y="3117960"/>
            <a:ext cx="731880" cy="1164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ts val="1687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Courier New"/>
              </a:rPr>
              <a:t>F-R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ts val="1687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Courier New"/>
              </a:rPr>
              <a:t>F+R+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ts val="1687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Courier New"/>
              </a:rPr>
              <a:t>F-R+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ts val="1687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Courier New"/>
              </a:rPr>
              <a:t>F+R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ts val="1687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Courier New"/>
              </a:rPr>
              <a:t>GroupN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8277120" y="1808280"/>
            <a:ext cx="21600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8709120" y="1808280"/>
            <a:ext cx="215640" cy="144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8348760" y="1808280"/>
            <a:ext cx="50328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8624880" y="1557360"/>
            <a:ext cx="800280" cy="187200"/>
          </a:xfrm>
          <a:prstGeom prst="rightArrow">
            <a:avLst>
              <a:gd name="adj1" fmla="val 57713"/>
              <a:gd name="adj2" fmla="val 67826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7821720" y="1557360"/>
            <a:ext cx="799920" cy="187200"/>
          </a:xfrm>
          <a:prstGeom prst="rightArrow">
            <a:avLst>
              <a:gd name="adj1" fmla="val 57713"/>
              <a:gd name="adj2" fmla="val 67795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8163000" y="1820880"/>
            <a:ext cx="48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8599320" y="1820880"/>
            <a:ext cx="532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flipH="1">
            <a:off x="8267760" y="2492280"/>
            <a:ext cx="21888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 flipH="1">
            <a:off x="8699040" y="2492280"/>
            <a:ext cx="21924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 flipH="1">
            <a:off x="8338680" y="2492280"/>
            <a:ext cx="50652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 flipH="1">
            <a:off x="8618400" y="2203560"/>
            <a:ext cx="798480" cy="187200"/>
          </a:xfrm>
          <a:prstGeom prst="rightArrow">
            <a:avLst>
              <a:gd name="adj1" fmla="val 57713"/>
              <a:gd name="adj2" fmla="val 67673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 flipH="1">
            <a:off x="7813800" y="2203560"/>
            <a:ext cx="799920" cy="187200"/>
          </a:xfrm>
          <a:prstGeom prst="rightArrow">
            <a:avLst>
              <a:gd name="adj1" fmla="val 57713"/>
              <a:gd name="adj2" fmla="val 67795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 flipH="1">
            <a:off x="8155080" y="2503440"/>
            <a:ext cx="48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 flipH="1">
            <a:off x="8589240" y="2503440"/>
            <a:ext cx="482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7370640" y="1125360"/>
            <a:ext cx="1459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ead_to_tai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8282160" y="3716280"/>
            <a:ext cx="21564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8713800" y="3716280"/>
            <a:ext cx="21600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8353440" y="3716280"/>
            <a:ext cx="50328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 flipH="1">
            <a:off x="8628120" y="3463920"/>
            <a:ext cx="799920" cy="187200"/>
          </a:xfrm>
          <a:prstGeom prst="rightArrow">
            <a:avLst>
              <a:gd name="adj1" fmla="val 57713"/>
              <a:gd name="adj2" fmla="val 67795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7826400" y="3463920"/>
            <a:ext cx="798480" cy="187200"/>
          </a:xfrm>
          <a:prstGeom prst="rightArrow">
            <a:avLst>
              <a:gd name="adj1" fmla="val 57713"/>
              <a:gd name="adj2" fmla="val 67673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7362000" y="3032280"/>
            <a:ext cx="1282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ail_to_tai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8163000" y="3727440"/>
            <a:ext cx="48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8599320" y="3727440"/>
            <a:ext cx="481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7373880" y="4282920"/>
            <a:ext cx="167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ead_to_hea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 flipH="1">
            <a:off x="8286840" y="5011560"/>
            <a:ext cx="21888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 flipH="1">
            <a:off x="8718120" y="5011560"/>
            <a:ext cx="21924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 flipH="1">
            <a:off x="8357760" y="5011560"/>
            <a:ext cx="50652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8637480" y="4724280"/>
            <a:ext cx="798480" cy="187560"/>
          </a:xfrm>
          <a:prstGeom prst="rightArrow">
            <a:avLst>
              <a:gd name="adj1" fmla="val 57713"/>
              <a:gd name="adj2" fmla="val 67543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 flipH="1">
            <a:off x="7832880" y="4724280"/>
            <a:ext cx="799920" cy="187560"/>
          </a:xfrm>
          <a:prstGeom prst="rightArrow">
            <a:avLst>
              <a:gd name="adj1" fmla="val 57713"/>
              <a:gd name="adj2" fmla="val 67665"/>
            </a:avLst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 flipH="1">
            <a:off x="8174160" y="5024520"/>
            <a:ext cx="48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 flipH="1">
            <a:off x="8609040" y="5024520"/>
            <a:ext cx="48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7370640" y="1125360"/>
            <a:ext cx="1459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ead_to_tai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7977240" y="5565600"/>
            <a:ext cx="644400" cy="367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osi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8265960" y="5932440"/>
            <a:ext cx="21600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8697960" y="5932440"/>
            <a:ext cx="216000" cy="1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8337600" y="5932440"/>
            <a:ext cx="50328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9134640" y="5683320"/>
            <a:ext cx="58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:M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8521560" y="5541840"/>
            <a:ext cx="6447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Position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7977240" y="5516640"/>
            <a:ext cx="1657440" cy="5364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57240" y="66600"/>
            <a:ext cx="18000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uppl. Fig. 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128520" y="466560"/>
            <a:ext cx="950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apping of the mate-pairs (MPs) covering the junctions of EG10 copies in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gpt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delta mice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7940520" y="1521000"/>
            <a:ext cx="532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8742240" y="1521000"/>
            <a:ext cx="532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8742240" y="2155680"/>
            <a:ext cx="532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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7950240" y="2155680"/>
            <a:ext cx="531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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8769240" y="3392640"/>
            <a:ext cx="532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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7950240" y="4664160"/>
            <a:ext cx="531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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8742240" y="4689360"/>
            <a:ext cx="532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7937640" y="3417840"/>
            <a:ext cx="531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7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3-10T03:26:47Z</dcterms:created>
  <dc:creator>dgm2</dc:creator>
  <dc:description/>
  <dc:language>en-US</dc:language>
  <cp:lastModifiedBy>masumura</cp:lastModifiedBy>
  <cp:lastPrinted>2015-08-31T08:41:32Z</cp:lastPrinted>
  <dcterms:modified xsi:type="dcterms:W3CDTF">2015-10-01T07:44:08Z</dcterms:modified>
  <cp:revision>260</cp:revision>
  <dc:subject/>
  <dc:title>スライド 1</dc:title>
</cp:coreProperties>
</file>